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embeddings/oleObject3.xlsx" ContentType="application/vnd.openxmlformats-officedocument.spreadsheetml.sheet"/>
  <Override PartName="/ppt/embeddings/oleObject4.xlsx" ContentType="application/vnd.openxmlformats-officedocument.spreadsheetml.sheet"/>
  <Override PartName="/ppt/media/image1.wmf" ContentType="image/x-wmf"/>
  <Override PartName="/ppt/media/image2.png" ContentType="image/png"/>
  <Override PartName="/ppt/media/image3.wmf" ContentType="image/x-wmf"/>
  <Override PartName="/ppt/media/image4.png" ContentType="image/png"/>
  <Override PartName="/ppt/media/image5.wmf" ContentType="image/x-wmf"/>
  <Override PartName="/ppt/media/image6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2207A9-F187-46A9-B80C-9E642E38008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C2EE94-35B4-4DAD-B924-CDDCC1E4768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78FB96-3854-47FF-B9DC-C5B0CFA1ED9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E62A63-E4D1-44AB-B1E2-075287E3DED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EFCC2D-B675-48BF-AA23-75597E8B84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5A2E8D-BAD3-4B39-A839-5BEB1BFF136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A97B25-01D2-44FD-A688-8092ED01AD9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649841-C527-4C9B-A02F-A22EEB8BB18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D73250-47C3-45AA-AE98-EBB51D1E5D3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AB90D8-DF0F-42CF-A1CC-5BA2822A6A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1C998A-C9E1-42E2-AD28-4851D0F475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C7953A-E807-4A74-A0C0-B9001C316D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7AB244D-7068-42CC-AB90-3A8C3903C31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image" Target="../media/image2.png"/><Relationship Id="rId4" Type="http://schemas.openxmlformats.org/officeDocument/2006/relationships/package" Target="../embeddings/oleObject2.xlsx"/><Relationship Id="rId5" Type="http://schemas.openxmlformats.org/officeDocument/2006/relationships/image" Target="../media/image3.wmf"/><Relationship Id="rId6" Type="http://schemas.openxmlformats.org/officeDocument/2006/relationships/image" Target="../media/image4.png"/><Relationship Id="rId7" Type="http://schemas.openxmlformats.org/officeDocument/2006/relationships/package" Target="../embeddings/oleObject3.xlsx"/><Relationship Id="rId8" Type="http://schemas.openxmlformats.org/officeDocument/2006/relationships/image" Target="../media/image5.wmf"/><Relationship Id="rId9" Type="http://schemas.openxmlformats.org/officeDocument/2006/relationships/package" Target="../embeddings/oleObject4.xlsx"/><Relationship Id="rId10" Type="http://schemas.openxmlformats.org/officeDocument/2006/relationships/image" Target="../media/image6.wmf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647640" y="4495680"/>
          <a:ext cx="4229280" cy="211464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647640" y="4495680"/>
                    <a:ext cx="4229280" cy="2114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pSp>
        <p:nvGrpSpPr>
          <p:cNvPr id="43" name=""/>
          <p:cNvGrpSpPr/>
          <p:nvPr/>
        </p:nvGrpSpPr>
        <p:grpSpPr>
          <a:xfrm>
            <a:off x="-54720" y="4953960"/>
            <a:ext cx="4566960" cy="1891440"/>
            <a:chOff x="-54720" y="4953960"/>
            <a:chExt cx="4566960" cy="1891440"/>
          </a:xfrm>
        </p:grpSpPr>
        <p:sp>
          <p:nvSpPr>
            <p:cNvPr id="44" name=""/>
            <p:cNvSpPr/>
            <p:nvPr/>
          </p:nvSpPr>
          <p:spPr>
            <a:xfrm>
              <a:off x="-54720" y="6477120"/>
              <a:ext cx="4566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wt RANK(70ng)                +                           +                            +                             -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GFP-RANK-c (ng)             -                           35                         70                            +  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 rot="16200000">
              <a:off x="-85320" y="5472720"/>
              <a:ext cx="1284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Luciferase activity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6" name=""/>
          <p:cNvGrpSpPr/>
          <p:nvPr/>
        </p:nvGrpSpPr>
        <p:grpSpPr>
          <a:xfrm>
            <a:off x="5238720" y="5106600"/>
            <a:ext cx="3505320" cy="1306440"/>
            <a:chOff x="5238720" y="5106600"/>
            <a:chExt cx="3505320" cy="1306440"/>
          </a:xfrm>
        </p:grpSpPr>
        <p:pic>
          <p:nvPicPr>
            <p:cNvPr id="47" name="" descr=""/>
            <p:cNvPicPr/>
            <p:nvPr/>
          </p:nvPicPr>
          <p:blipFill>
            <a:blip r:embed="rId3"/>
            <a:srcRect l="0" t="16057" r="18660" b="67958"/>
            <a:stretch/>
          </p:blipFill>
          <p:spPr>
            <a:xfrm>
              <a:off x="6838920" y="5570640"/>
              <a:ext cx="1600200" cy="556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8" name=""/>
            <p:cNvSpPr/>
            <p:nvPr/>
          </p:nvSpPr>
          <p:spPr>
            <a:xfrm rot="16200000">
              <a:off x="6731640" y="5240880"/>
              <a:ext cx="545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mock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5458680" y="5605560"/>
              <a:ext cx="1241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wtRANK (70ng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5554800" y="5871960"/>
              <a:ext cx="1095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GFP-RANK-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6608880" y="5746680"/>
              <a:ext cx="228600" cy="9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800" bIns="-37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6602400" y="6014880"/>
              <a:ext cx="228600" cy="93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7477560" y="6081480"/>
              <a:ext cx="35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3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7791840" y="6081480"/>
              <a:ext cx="35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5238720" y="5118120"/>
              <a:ext cx="3505320" cy="129492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8106120" y="6080040"/>
              <a:ext cx="35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7202160" y="608004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8" name=""/>
          <p:cNvGrpSpPr/>
          <p:nvPr/>
        </p:nvGrpSpPr>
        <p:grpSpPr>
          <a:xfrm>
            <a:off x="-51840" y="2335320"/>
            <a:ext cx="8814960" cy="2301840"/>
            <a:chOff x="-51840" y="2335320"/>
            <a:chExt cx="8814960" cy="2301840"/>
          </a:xfrm>
        </p:grpSpPr>
        <p:graphicFrame>
          <p:nvGraphicFramePr>
            <p:cNvPr id="59" name=""/>
            <p:cNvGraphicFramePr/>
            <p:nvPr/>
          </p:nvGraphicFramePr>
          <p:xfrm>
            <a:off x="571680" y="2335320"/>
            <a:ext cx="4343400" cy="2058840"/>
          </p:xfrm>
          <a:graphic>
            <a:graphicData uri="http://schemas.openxmlformats.org/presentationml/2006/ole">
              <p:oleObj progId="Excel.Sheet.12" r:id="rId4" spid="">
                <p:embed/>
                <p:pic>
                  <p:nvPicPr>
                    <p:cNvPr id="60" name="" descr=""/>
                    <p:cNvPicPr/>
                    <p:nvPr/>
                  </p:nvPicPr>
                  <p:blipFill>
                    <a:blip r:embed="rId5"/>
                    <a:stretch/>
                  </p:blipFill>
                  <p:spPr>
                    <a:xfrm>
                      <a:off x="571680" y="2335320"/>
                      <a:ext cx="4343400" cy="20588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61" name=""/>
            <p:cNvSpPr/>
            <p:nvPr/>
          </p:nvSpPr>
          <p:spPr>
            <a:xfrm>
              <a:off x="-51840" y="4268880"/>
              <a:ext cx="4771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RANK-b (70ng)             +                      +                       +                      +                       +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RANK-c (ng)                  -                     1.7                     17                    35                     70  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 rot="16200000">
              <a:off x="-153720" y="3312360"/>
              <a:ext cx="1284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Luciferase activity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3" name=""/>
            <p:cNvGrpSpPr/>
            <p:nvPr/>
          </p:nvGrpSpPr>
          <p:grpSpPr>
            <a:xfrm>
              <a:off x="5257800" y="2688840"/>
              <a:ext cx="3505320" cy="1522800"/>
              <a:chOff x="5257800" y="2688840"/>
              <a:chExt cx="3505320" cy="1522800"/>
            </a:xfrm>
          </p:grpSpPr>
          <p:pic>
            <p:nvPicPr>
              <p:cNvPr id="64" name="" descr=""/>
              <p:cNvPicPr/>
              <p:nvPr/>
            </p:nvPicPr>
            <p:blipFill>
              <a:blip r:embed="rId6"/>
              <a:srcRect l="3429" t="76712" r="535" b="2192"/>
              <a:stretch/>
            </p:blipFill>
            <p:spPr>
              <a:xfrm>
                <a:off x="6786720" y="3206880"/>
                <a:ext cx="1828800" cy="685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5" name=""/>
              <p:cNvSpPr/>
              <p:nvPr/>
            </p:nvSpPr>
            <p:spPr>
              <a:xfrm rot="16200000">
                <a:off x="6636600" y="2823120"/>
                <a:ext cx="545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mock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5415480" y="3254400"/>
                <a:ext cx="12247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RANK-b (70ng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5523120" y="3492360"/>
                <a:ext cx="10951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GFP-RANK-c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6553440" y="3411720"/>
                <a:ext cx="22860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6534360" y="3649680"/>
                <a:ext cx="228600" cy="9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7953840" y="3878280"/>
                <a:ext cx="351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3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7658640" y="3878280"/>
                <a:ext cx="351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7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5257800" y="2700360"/>
                <a:ext cx="3505320" cy="151128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8268120" y="3878280"/>
                <a:ext cx="351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7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7095600" y="3878280"/>
                <a:ext cx="26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7315560" y="3878280"/>
                <a:ext cx="394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.7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76" name=""/>
          <p:cNvSpPr/>
          <p:nvPr/>
        </p:nvSpPr>
        <p:spPr>
          <a:xfrm>
            <a:off x="153720" y="1522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4887720" y="1522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8" name=""/>
          <p:cNvGrpSpPr/>
          <p:nvPr/>
        </p:nvGrpSpPr>
        <p:grpSpPr>
          <a:xfrm>
            <a:off x="4638960" y="47520"/>
            <a:ext cx="4276080" cy="2077920"/>
            <a:chOff x="4638960" y="47520"/>
            <a:chExt cx="4276080" cy="2077920"/>
          </a:xfrm>
        </p:grpSpPr>
        <p:graphicFrame>
          <p:nvGraphicFramePr>
            <p:cNvPr id="79" name=""/>
            <p:cNvGraphicFramePr/>
            <p:nvPr/>
          </p:nvGraphicFramePr>
          <p:xfrm>
            <a:off x="5181480" y="47520"/>
            <a:ext cx="3733560" cy="1770120"/>
          </p:xfrm>
          <a:graphic>
            <a:graphicData uri="http://schemas.openxmlformats.org/presentationml/2006/ole">
              <p:oleObj progId="Excel.Sheet.12" r:id="rId7" spid="">
                <p:embed/>
                <p:pic>
                  <p:nvPicPr>
                    <p:cNvPr id="80" name="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5181480" y="47520"/>
                      <a:ext cx="3733560" cy="17701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81" name=""/>
            <p:cNvSpPr/>
            <p:nvPr/>
          </p:nvSpPr>
          <p:spPr>
            <a:xfrm>
              <a:off x="4638960" y="1757160"/>
              <a:ext cx="37209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wtRANK (70ng)            +                     +                     +                      -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RANK-b (ng)                 -                    17                   35                    7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2" name=""/>
          <p:cNvSpPr/>
          <p:nvPr/>
        </p:nvSpPr>
        <p:spPr>
          <a:xfrm>
            <a:off x="126720" y="24685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125280" y="47545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84" name=""/>
          <p:cNvGraphicFramePr/>
          <p:nvPr/>
        </p:nvGraphicFramePr>
        <p:xfrm>
          <a:off x="609480" y="42840"/>
          <a:ext cx="3657600" cy="1733400"/>
        </p:xfrm>
        <a:graphic>
          <a:graphicData uri="http://schemas.openxmlformats.org/presentationml/2006/ole">
            <p:oleObj progId="Excel.Sheet.12" r:id="rId9" spid="">
              <p:embed/>
              <p:pic>
                <p:nvPicPr>
                  <p:cNvPr id="85" name="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609480" y="42840"/>
                    <a:ext cx="3657600" cy="17334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86" name=""/>
          <p:cNvSpPr/>
          <p:nvPr/>
        </p:nvSpPr>
        <p:spPr>
          <a:xfrm rot="16200000">
            <a:off x="-75960" y="824760"/>
            <a:ext cx="1284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Luciferase activit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 rot="16200000">
            <a:off x="4676760" y="900720"/>
            <a:ext cx="1284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Luciferase activit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-10800" y="1628640"/>
            <a:ext cx="39938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wt RANK                      +                         +                       +                       +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RANK-a                        -                          +                       -                        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RANK-b                        -                          -                        +                       -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RANK-c                        -                          -                         -                       +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3749400" y="90792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3520800" y="111132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3635280" y="315432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3363480" y="352584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4425840" y="324972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4140000" y="3468600"/>
            <a:ext cx="240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2-19T14:00:08Z</dcterms:created>
  <dc:creator>tasos p</dc:creator>
  <dc:description/>
  <dc:language>en-US</dc:language>
  <cp:lastModifiedBy>tasos p</cp:lastModifiedBy>
  <dcterms:modified xsi:type="dcterms:W3CDTF">2012-01-29T18:01:35Z</dcterms:modified>
  <cp:revision>12</cp:revision>
  <dc:subject/>
  <dc:title>Διαφάνεια 1</dc:title>
</cp:coreProperties>
</file>